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5" r:id="rId2"/>
    <p:sldId id="266" r:id="rId3"/>
  </p:sldIdLst>
  <p:sldSz cx="6858000" cy="9144000" type="screen4x3"/>
  <p:notesSz cx="6794500" cy="99314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-756" y="212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48100" y="0"/>
            <a:ext cx="294481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0D5788-B9F8-4221-9A52-8A7885420084}" type="datetimeFigureOut">
              <a:rPr lang="en-US" smtClean="0"/>
              <a:t>1/19/2022</a:t>
            </a:fld>
            <a:endParaRPr lang="en-U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000250" y="744538"/>
            <a:ext cx="2794000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450" y="4718050"/>
            <a:ext cx="5435600" cy="44688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32925"/>
            <a:ext cx="2944813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48100" y="9432925"/>
            <a:ext cx="2944813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DF2D86-D148-4725-8B70-F804EF365D1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6283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D3B2F-3BA2-46E5-8FC6-A4C68C4B8194}" type="datetimeFigureOut">
              <a:rPr lang="it-IT" smtClean="0"/>
              <a:t>19/01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F7A5E-7A95-4922-8F82-C16EC0B898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0518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D3B2F-3BA2-46E5-8FC6-A4C68C4B8194}" type="datetimeFigureOut">
              <a:rPr lang="it-IT" smtClean="0"/>
              <a:t>19/01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F7A5E-7A95-4922-8F82-C16EC0B898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79735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D3B2F-3BA2-46E5-8FC6-A4C68C4B8194}" type="datetimeFigureOut">
              <a:rPr lang="it-IT" smtClean="0"/>
              <a:t>19/01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F7A5E-7A95-4922-8F82-C16EC0B898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12460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D3B2F-3BA2-46E5-8FC6-A4C68C4B8194}" type="datetimeFigureOut">
              <a:rPr lang="it-IT" smtClean="0"/>
              <a:t>19/01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F7A5E-7A95-4922-8F82-C16EC0B898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687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D3B2F-3BA2-46E5-8FC6-A4C68C4B8194}" type="datetimeFigureOut">
              <a:rPr lang="it-IT" smtClean="0"/>
              <a:t>19/01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F7A5E-7A95-4922-8F82-C16EC0B898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05520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D3B2F-3BA2-46E5-8FC6-A4C68C4B8194}" type="datetimeFigureOut">
              <a:rPr lang="it-IT" smtClean="0"/>
              <a:t>19/01/20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F7A5E-7A95-4922-8F82-C16EC0B898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99301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D3B2F-3BA2-46E5-8FC6-A4C68C4B8194}" type="datetimeFigureOut">
              <a:rPr lang="it-IT" smtClean="0"/>
              <a:t>19/01/2022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F7A5E-7A95-4922-8F82-C16EC0B898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66492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D3B2F-3BA2-46E5-8FC6-A4C68C4B8194}" type="datetimeFigureOut">
              <a:rPr lang="it-IT" smtClean="0"/>
              <a:t>19/01/2022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F7A5E-7A95-4922-8F82-C16EC0B898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5304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D3B2F-3BA2-46E5-8FC6-A4C68C4B8194}" type="datetimeFigureOut">
              <a:rPr lang="it-IT" smtClean="0"/>
              <a:t>19/01/2022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F7A5E-7A95-4922-8F82-C16EC0B898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472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D3B2F-3BA2-46E5-8FC6-A4C68C4B8194}" type="datetimeFigureOut">
              <a:rPr lang="it-IT" smtClean="0"/>
              <a:t>19/01/20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F7A5E-7A95-4922-8F82-C16EC0B898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01736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D3B2F-3BA2-46E5-8FC6-A4C68C4B8194}" type="datetimeFigureOut">
              <a:rPr lang="it-IT" smtClean="0"/>
              <a:t>19/01/20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F7A5E-7A95-4922-8F82-C16EC0B898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04071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FD3B2F-3BA2-46E5-8FC6-A4C68C4B8194}" type="datetimeFigureOut">
              <a:rPr lang="it-IT" smtClean="0"/>
              <a:t>19/01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BF7A5E-7A95-4922-8F82-C16EC0B898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087270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asellaDiTesto 10"/>
          <p:cNvSpPr txBox="1"/>
          <p:nvPr/>
        </p:nvSpPr>
        <p:spPr>
          <a:xfrm>
            <a:off x="1124744" y="179512"/>
            <a:ext cx="48965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Table </a:t>
            </a:r>
            <a:r>
              <a:rPr lang="en-GB" sz="1050" b="1" dirty="0" smtClean="0"/>
              <a:t>S1</a:t>
            </a:r>
            <a:r>
              <a:rPr lang="en-GB" sz="1050" b="1" dirty="0"/>
              <a:t>.</a:t>
            </a:r>
            <a:r>
              <a:rPr lang="en-GB" sz="1050" dirty="0"/>
              <a:t> Differentially expressed miRNAs in </a:t>
            </a:r>
            <a:r>
              <a:rPr lang="en-GB" sz="1050" dirty="0" smtClean="0"/>
              <a:t>WBI  </a:t>
            </a:r>
            <a:r>
              <a:rPr lang="en-GB" sz="1050" i="1" dirty="0"/>
              <a:t>vs</a:t>
            </a:r>
            <a:r>
              <a:rPr lang="en-GB" sz="1050" dirty="0"/>
              <a:t> </a:t>
            </a:r>
            <a:r>
              <a:rPr lang="en-GB" sz="1050" dirty="0" smtClean="0"/>
              <a:t>SI plasma-derived exosomes </a:t>
            </a:r>
            <a:endParaRPr lang="en-US" sz="1050" dirty="0"/>
          </a:p>
        </p:txBody>
      </p:sp>
      <p:graphicFrame>
        <p:nvGraphicFramePr>
          <p:cNvPr id="5" name="Tabel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9895778"/>
              </p:ext>
            </p:extLst>
          </p:nvPr>
        </p:nvGraphicFramePr>
        <p:xfrm>
          <a:off x="1268760" y="467544"/>
          <a:ext cx="3384376" cy="8403699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12168"/>
                <a:gridCol w="1008112"/>
                <a:gridCol w="864096"/>
              </a:tblGrid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 err="1">
                          <a:effectLst/>
                        </a:rPr>
                        <a:t>miRNA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logFC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PValue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 anchor="b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99b-3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Infinity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0.0002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141-3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824282923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0.0001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14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824282923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0.0001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30e-5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766464249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0.0048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30a-5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62320639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0.0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200a-3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373725293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0.0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30a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36458614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0.0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200a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31031789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221-3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21409900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28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22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21409900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28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25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208000316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25-3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20674284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6-5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19139886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0.0002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6-1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176849874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0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30e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066031065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0.0017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6-2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050931965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0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22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2.74262534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9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22-3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2.742156745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9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143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2.66827883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1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43-3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2.66827883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1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let-7j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2.66125650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04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93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2.61584233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15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93-5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2.61552029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16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140-3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2.596325669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04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40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2.466130354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05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30d-5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2.44928698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46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361-5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448174053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20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30d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438898781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48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28-3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438898781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0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28-2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432921038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0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28-1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355253386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04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let-7i-5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355253386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1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let-7i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322433009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1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46b-5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322433009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46b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297048339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361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182717411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396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25b-2-3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082880755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433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198-5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082880755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20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198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009369803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20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148a-5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1.951988666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20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mmu-miR-1839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  <a:latin typeface="+mn-lt"/>
                          <a:ea typeface="+mn-ea"/>
                          <a:cs typeface="+mn-cs"/>
                        </a:rPr>
                        <a:t>1.951988666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09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mmu-miR-1839-5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1.95115458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09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mmu-mir-199-b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1.84902330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47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dirty="0" smtClean="0">
                          <a:effectLst/>
                        </a:rPr>
                        <a:t>mmu-mir-199-b</a:t>
                      </a:r>
                      <a:r>
                        <a:rPr lang="en-US" sz="800" dirty="0" smtClean="0">
                          <a:effectLst/>
                          <a:latin typeface="Calibri"/>
                          <a:cs typeface="Times New Roman"/>
                        </a:rPr>
                        <a:t>-3p</a:t>
                      </a:r>
                      <a:endParaRPr lang="en-US" sz="800" dirty="0" smtClean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1.847860383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47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mmu-miR-199a-3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1.847860383</a:t>
                      </a:r>
                      <a:endParaRPr lang="en-US" sz="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477</a:t>
                      </a:r>
                      <a:endParaRPr lang="en-US" sz="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dirty="0" smtClean="0">
                          <a:effectLst/>
                        </a:rPr>
                        <a:t>mmu-miR-199a-1</a:t>
                      </a:r>
                      <a:endParaRPr lang="en-US" sz="800" dirty="0" smtClean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.847382497</a:t>
                      </a:r>
                      <a:endParaRPr lang="en-US" sz="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0.0493</a:t>
                      </a:r>
                      <a:endParaRPr lang="en-US" sz="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mmu-miR-21a-5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  <a:latin typeface="+mn-lt"/>
                          <a:ea typeface="+mn-ea"/>
                          <a:cs typeface="+mn-cs"/>
                        </a:rPr>
                        <a:t>1.84386054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214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mmu-mir-21a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  <a:latin typeface="+mn-lt"/>
                          <a:ea typeface="+mn-ea"/>
                          <a:cs typeface="+mn-cs"/>
                        </a:rPr>
                        <a:t>1.843838473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16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mmu-mir-182-5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1.840565727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078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mmu-miR-18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1.8142204444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09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mmu-mir-146-a-5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1.78335979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078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mmu-mir-146a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1.78335979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078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mmu-miR-1a-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1.685863453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33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mmu-miR-1a-3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1.685863453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33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mmu-mir-1a-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1.685390869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33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mmu-mir-106b-3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1.594954773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27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  <a:tr h="2581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mmu-mir-106b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1.578341563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smtClean="0">
                          <a:effectLst/>
                        </a:rPr>
                        <a:t>0.029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3933" marR="33933" marT="0" marB="0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722046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9908996"/>
              </p:ext>
            </p:extLst>
          </p:nvPr>
        </p:nvGraphicFramePr>
        <p:xfrm>
          <a:off x="1196752" y="1475656"/>
          <a:ext cx="3384376" cy="250194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340979"/>
                <a:gridCol w="893986"/>
                <a:gridCol w="1149411"/>
              </a:tblGrid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 err="1">
                          <a:effectLst/>
                        </a:rPr>
                        <a:t>miRNA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logFC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PValue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99b-3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err="1">
                          <a:effectLst/>
                        </a:rPr>
                        <a:t>Infinity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41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err="1">
                          <a:effectLst/>
                        </a:rPr>
                        <a:t>Infinity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0.0101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411-5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err="1">
                          <a:effectLst/>
                        </a:rPr>
                        <a:t>Infinity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10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200a-3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4.126708628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200a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4.0581269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032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84-3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17844653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84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3.178446537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429-3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2.816872863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476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429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2.816872863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476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82-5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2.746571479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403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182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72025135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453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320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203557278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18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mmu-miR-320-3p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2.203524326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18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 err="1">
                          <a:effectLst/>
                        </a:rPr>
                        <a:t>miRNA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logFC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PValue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99b-3p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err="1">
                          <a:effectLst/>
                        </a:rPr>
                        <a:t>Infinity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>
                          <a:effectLst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</a:tr>
              <a:tr h="1471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mmu-mir-41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 err="1">
                          <a:effectLst/>
                        </a:rPr>
                        <a:t>Infinity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800" dirty="0">
                          <a:effectLst/>
                        </a:rPr>
                        <a:t>0.0101</a:t>
                      </a:r>
                      <a:endParaRPr lang="en-US" sz="8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/>
                </a:tc>
              </a:tr>
            </a:tbl>
          </a:graphicData>
        </a:graphic>
      </p:graphicFrame>
      <p:sp>
        <p:nvSpPr>
          <p:cNvPr id="7" name="Rettangolo 6"/>
          <p:cNvSpPr/>
          <p:nvPr/>
        </p:nvSpPr>
        <p:spPr>
          <a:xfrm>
            <a:off x="1092940" y="1187624"/>
            <a:ext cx="4680520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50" b="1" dirty="0"/>
              <a:t>Table S2.</a:t>
            </a:r>
            <a:r>
              <a:rPr lang="en-GB" sz="1050" dirty="0"/>
              <a:t> Differentially expressed miRNAs in </a:t>
            </a:r>
            <a:r>
              <a:rPr lang="en-GB" sz="1050" dirty="0" smtClean="0"/>
              <a:t>PBI  </a:t>
            </a:r>
            <a:r>
              <a:rPr lang="en-GB" sz="1050" i="1" dirty="0"/>
              <a:t>vs </a:t>
            </a:r>
            <a:r>
              <a:rPr lang="en-GB" sz="1050" dirty="0"/>
              <a:t>SI </a:t>
            </a:r>
            <a:r>
              <a:rPr lang="en-GB" sz="1050" dirty="0" smtClean="0"/>
              <a:t>plasma-derived exosomes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val="36919776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43</TotalTime>
  <Words>250</Words>
  <Application>Microsoft Office PowerPoint</Application>
  <PresentationFormat>Presentazione su schermo (4:3)</PresentationFormat>
  <Paragraphs>227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3" baseType="lpstr">
      <vt:lpstr>Tema di Offic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imona</dc:creator>
  <cp:lastModifiedBy>simona</cp:lastModifiedBy>
  <cp:revision>156</cp:revision>
  <cp:lastPrinted>2021-09-03T10:12:47Z</cp:lastPrinted>
  <dcterms:created xsi:type="dcterms:W3CDTF">2020-06-16T10:05:56Z</dcterms:created>
  <dcterms:modified xsi:type="dcterms:W3CDTF">2022-01-19T11:47:41Z</dcterms:modified>
</cp:coreProperties>
</file>